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55" d="100"/>
          <a:sy n="55" d="100"/>
        </p:scale>
        <p:origin x="-1806" y="-3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5A7F-AE97-4FD9-A6C1-E665C6425F6C}" type="datetimeFigureOut">
              <a:rPr lang="de-DE" smtClean="0"/>
              <a:t>22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F1084-0474-42D0-9A19-52A8856C3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3677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5A7F-AE97-4FD9-A6C1-E665C6425F6C}" type="datetimeFigureOut">
              <a:rPr lang="de-DE" smtClean="0"/>
              <a:t>22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F1084-0474-42D0-9A19-52A8856C3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6181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5A7F-AE97-4FD9-A6C1-E665C6425F6C}" type="datetimeFigureOut">
              <a:rPr lang="de-DE" smtClean="0"/>
              <a:t>22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F1084-0474-42D0-9A19-52A8856C3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5875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5A7F-AE97-4FD9-A6C1-E665C6425F6C}" type="datetimeFigureOut">
              <a:rPr lang="de-DE" smtClean="0"/>
              <a:t>22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F1084-0474-42D0-9A19-52A8856C3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1613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5A7F-AE97-4FD9-A6C1-E665C6425F6C}" type="datetimeFigureOut">
              <a:rPr lang="de-DE" smtClean="0"/>
              <a:t>22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F1084-0474-42D0-9A19-52A8856C3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732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5A7F-AE97-4FD9-A6C1-E665C6425F6C}" type="datetimeFigureOut">
              <a:rPr lang="de-DE" smtClean="0"/>
              <a:t>22.05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F1084-0474-42D0-9A19-52A8856C3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7126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5A7F-AE97-4FD9-A6C1-E665C6425F6C}" type="datetimeFigureOut">
              <a:rPr lang="de-DE" smtClean="0"/>
              <a:t>22.05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F1084-0474-42D0-9A19-52A8856C3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8473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5A7F-AE97-4FD9-A6C1-E665C6425F6C}" type="datetimeFigureOut">
              <a:rPr lang="de-DE" smtClean="0"/>
              <a:t>22.05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F1084-0474-42D0-9A19-52A8856C3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7681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5A7F-AE97-4FD9-A6C1-E665C6425F6C}" type="datetimeFigureOut">
              <a:rPr lang="de-DE" smtClean="0"/>
              <a:t>22.05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F1084-0474-42D0-9A19-52A8856C3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2166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5A7F-AE97-4FD9-A6C1-E665C6425F6C}" type="datetimeFigureOut">
              <a:rPr lang="de-DE" smtClean="0"/>
              <a:t>22.05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F1084-0474-42D0-9A19-52A8856C3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1025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5A7F-AE97-4FD9-A6C1-E665C6425F6C}" type="datetimeFigureOut">
              <a:rPr lang="de-DE" smtClean="0"/>
              <a:t>22.05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F1084-0474-42D0-9A19-52A8856C3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2891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325A7F-AE97-4FD9-A6C1-E665C6425F6C}" type="datetimeFigureOut">
              <a:rPr lang="de-DE" smtClean="0"/>
              <a:t>22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5F1084-0474-42D0-9A19-52A8856C3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7424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5313082" y="1124744"/>
            <a:ext cx="3651406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: Akt1 and Akt3 but not Ak2 interact with the C-terminus of DNA-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Kcs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549 cells were transfected with the indicated plasmids. Twenty-four hours after transfection, the medium was changed to fresh medium. Forty-eight hours after transfection, the cells were irradiated with 4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d lysed 10 min post-irradiation. An IP of th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tagged proteins was performed using the GFP-Trap, and the input and bound fractions were subjected to SDS-PAGE. The levels of the GFP, RFP and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isoforms were detected using Western blotting with specific antibodies. The arrow indicates the signal from Akt1 due to the lack of a complete stripping.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89" r="7865"/>
          <a:stretch/>
        </p:blipFill>
        <p:spPr>
          <a:xfrm>
            <a:off x="179512" y="616065"/>
            <a:ext cx="4903246" cy="55892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16406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6512" y="0"/>
            <a:ext cx="4672786" cy="6858000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4932040" y="855871"/>
            <a:ext cx="3816424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. S2: Expression levels of the </a:t>
            </a:r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isoforms following co-transfection with </a:t>
            </a:r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isoforms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549 cells were transfected with the indicated plasmids. The medium was changed to fresh medium twenty-four hours post-transfection. Forty-eight hours after transfection, the cells were irradiated with 4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and lysed 10 min post-irradiation. The levels of GFP expression and the expression of endogenous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isoforms and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isoforms after transfection were analyzed by Western blotting using specific antibodies.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50236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4495733" y="1492329"/>
            <a:ext cx="4320480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. S3: Akt1 and Akt3 but not Ak2 interact with DNA-</a:t>
            </a:r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PKcs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in breast cancer cells.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K-RAS-mutated MDA-MB-231 cells were transfected with the indicated plasmids. Forty-eight hours after the transfection, the cells lysates were prepared. IP of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was performed using GFP-Trap as described in the Methods section. The co-IPs of Akt1, Akt2, and Akt3 were analyzed by western blotting using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specific antibodies. 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96" y="315188"/>
            <a:ext cx="4339710" cy="61381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50236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6</Words>
  <Application>Microsoft Office PowerPoint</Application>
  <PresentationFormat>Bildschirmpräsentation (4:3)</PresentationFormat>
  <Paragraphs>6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T</dc:creator>
  <cp:lastModifiedBy>MT</cp:lastModifiedBy>
  <cp:revision>5</cp:revision>
  <dcterms:created xsi:type="dcterms:W3CDTF">2017-03-21T22:07:02Z</dcterms:created>
  <dcterms:modified xsi:type="dcterms:W3CDTF">2017-05-22T22:19:36Z</dcterms:modified>
</cp:coreProperties>
</file>